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>
        <p:scale>
          <a:sx n="100" d="100"/>
          <a:sy n="100" d="100"/>
        </p:scale>
        <p:origin x="2376" y="-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64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957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189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478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072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25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134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45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505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75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58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683053-AF64-4825-BAA9-E17A57085F6B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44647-7418-4253-BBAF-1B080EB2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243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1240398"/>
              </p:ext>
            </p:extLst>
          </p:nvPr>
        </p:nvGraphicFramePr>
        <p:xfrm>
          <a:off x="2265853" y="872375"/>
          <a:ext cx="2814638" cy="20531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9" r:id="rId3" imgW="3127058" imgH="2280856" progId="Prism9.Document">
                  <p:embed/>
                </p:oleObj>
              </mc:Choice>
              <mc:Fallback>
                <p:oleObj name="Prism 9" r:id="rId3" imgW="3127058" imgH="2280856" progId="Prism9.Document">
                  <p:embed/>
                  <p:pic>
                    <p:nvPicPr>
                      <p:cNvPr id="785" name="Object 78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65853" y="872375"/>
                        <a:ext cx="2814638" cy="20531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102235" y="2633103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02235" y="2388379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102235" y="2096627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02235" y="1828389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102235" y="1552313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02235" y="1284075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02235" y="1007999"/>
            <a:ext cx="30469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725261" y="1795438"/>
            <a:ext cx="790890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EX1 IgG RE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097194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80631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412450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588832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65214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117978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654493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70820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745068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561631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921131" y="2770356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941596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478116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94360" y="2770356"/>
            <a:ext cx="270074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14796" y="2925488"/>
            <a:ext cx="1219372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eeks Post-SIV Infectio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890271" y="2633103"/>
            <a:ext cx="218137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890271" y="2100616"/>
            <a:ext cx="322011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890271" y="1554063"/>
            <a:ext cx="373948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890271" y="1004137"/>
            <a:ext cx="373948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009889" y="1103000"/>
            <a:ext cx="828401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+ T cells/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009889" y="1331600"/>
            <a:ext cx="844269" cy="193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EX1+ IgG RET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977088" y="862633"/>
            <a:ext cx="1410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4-15 (Cohort 1 VAX)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4804844" y="1799866"/>
            <a:ext cx="8851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+ T cells/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647439" y="1647825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78211" y="3318659"/>
            <a:ext cx="55435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CD4+ T cell and KEX1 IgG profiles for KEX1-vaccinated rhesus macaque 74-15 (Cohort 1 VAX) following SIV-infection and therapeutic boosting with </a:t>
            </a:r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C + KEX1 at 10 and 14 weeks post-infec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ipheral blood CD4+ T cell numbers, plasma KEX1 IgG reciprocal endpoint titer (RET). Thick dashed line indicates 500 CD4+ T cells/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Dotted dashed line indicates the correlate of protection at 10,000 KEX1 IgG RET. (+) Plus sign indicates the timepoint when BAL fluid or lung homogenate was positive for Pneumocystis infection by first-round PCR or immunohistochemistry staining of lung sections with anti-Pneumocystis clone 3F6. </a:t>
            </a:r>
          </a:p>
        </p:txBody>
      </p:sp>
    </p:spTree>
    <p:extLst>
      <p:ext uri="{BB962C8B-B14F-4D97-AF65-F5344CB8AC3E}">
        <p14:creationId xmlns:p14="http://schemas.microsoft.com/office/powerpoint/2010/main" val="2496463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70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ney Rabacal</dc:creator>
  <cp:lastModifiedBy>Whitney Rabacal</cp:lastModifiedBy>
  <cp:revision>9</cp:revision>
  <dcterms:created xsi:type="dcterms:W3CDTF">2022-03-03T22:25:38Z</dcterms:created>
  <dcterms:modified xsi:type="dcterms:W3CDTF">2022-10-30T18:15:23Z</dcterms:modified>
</cp:coreProperties>
</file>